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306" r:id="rId3"/>
    <p:sldId id="261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6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4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3025F-866A-4BEB-97A1-28F7A3ED8B7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80F9B-496B-49F1-82F4-0F04AF31D6D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2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tags" Target="../tags/tag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/>
          <p:nvPr>
            <p:custDataLst>
              <p:tags r:id="rId1"/>
            </p:custDataLst>
          </p:nvPr>
        </p:nvGraphicFramePr>
        <p:xfrm>
          <a:off x="1618615" y="1797685"/>
          <a:ext cx="8306435" cy="8191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81430"/>
                <a:gridCol w="1263650"/>
                <a:gridCol w="1760855"/>
                <a:gridCol w="4000500"/>
              </a:tblGrid>
              <a:tr h="81915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ORF1</a:t>
                      </a:r>
                      <a:endParaRPr lang="en-US" altLang="zh-CN" sz="2000">
                        <a:solidFill>
                          <a:schemeClr val="tx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a:txBody>
                  <a:tcPr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200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ORF2</a:t>
                      </a:r>
                      <a:endParaRPr lang="en-US" sz="2000">
                        <a:solidFill>
                          <a:schemeClr val="tx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a:txBody>
                  <a:tcPr anchor="ctr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200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ORF3</a:t>
                      </a:r>
                      <a:endParaRPr lang="en-US" sz="2000">
                        <a:solidFill>
                          <a:schemeClr val="tx1"/>
                        </a:solidFill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ORF4</a:t>
                      </a:r>
                      <a:r>
                        <a:rPr lang="zh-CN" altLang="en-US" sz="2000" dirty="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（</a:t>
                      </a:r>
                      <a:r>
                        <a:rPr lang="en-US" sz="2000" dirty="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RDRP</a:t>
                      </a:r>
                      <a:r>
                        <a:rPr lang="zh-CN" altLang="en-US" sz="2000" dirty="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）</a:t>
                      </a:r>
                      <a:endParaRPr lang="zh-CN" altLang="en-US" sz="2000" dirty="0">
                        <a:solidFill>
                          <a:schemeClr val="tx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  <a:p>
                      <a:pPr algn="ctr">
                        <a:buNone/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338aa</a:t>
                      </a:r>
                      <a:endParaRPr lang="en-US" sz="2000" dirty="0">
                        <a:solidFill>
                          <a:schemeClr val="tx1"/>
                        </a:solidFill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a:txBody>
                  <a:tcPr anchor="ctr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2249805" y="3171190"/>
            <a:ext cx="3308985" cy="66294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zh-CN" altLang="en-US" sz="2400" dirty="0">
                <a:latin typeface="Times New Roman" panose="02020603050405020304" charset="0"/>
                <a:cs typeface="Times New Roman" panose="02020603050405020304" charset="0"/>
              </a:rPr>
              <a:t>hypothetical protein</a:t>
            </a:r>
            <a:endParaRPr lang="zh-CN" altLang="en-US" sz="2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左大括号 3"/>
          <p:cNvSpPr/>
          <p:nvPr/>
        </p:nvSpPr>
        <p:spPr>
          <a:xfrm rot="16200000">
            <a:off x="3355340" y="1952625"/>
            <a:ext cx="357505" cy="188277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5743575" y="1314450"/>
            <a:ext cx="704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</a:rPr>
              <a:t>?</a:t>
            </a:r>
            <a:endParaRPr lang="en-US" altLang="zh-CN">
              <a:latin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347877" y="4940575"/>
            <a:ext cx="968530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Figure S1: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Schematic representation of DpLV with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complete ORF4(RDRP).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H</a:t>
            </a:r>
            <a:r>
              <a:rPr lang="zh-CN" altLang="en-US" sz="1800" dirty="0">
                <a:latin typeface="Times New Roman" panose="02020603050405020304" charset="0"/>
                <a:cs typeface="Times New Roman" panose="02020603050405020304" charset="0"/>
              </a:rPr>
              <a:t>ypothetical protein </a:t>
            </a:r>
            <a:r>
              <a:rPr lang="en-US" altLang="zh-CN" sz="1800" dirty="0">
                <a:latin typeface="Times New Roman" panose="02020603050405020304" charset="0"/>
                <a:cs typeface="Times New Roman" panose="02020603050405020304" charset="0"/>
              </a:rPr>
              <a:t>was predicted</a:t>
            </a:r>
            <a:r>
              <a:rPr lang="zh-CN" altLang="en-US" sz="18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800" dirty="0">
                <a:latin typeface="Times New Roman" panose="02020603050405020304" charset="0"/>
                <a:cs typeface="Times New Roman" panose="02020603050405020304" charset="0"/>
              </a:rPr>
              <a:t>according to </a:t>
            </a:r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maize </a:t>
            </a:r>
            <a:r>
              <a:rPr lang="en-US" altLang="zh-CN" sz="1800" dirty="0" err="1">
                <a:effectLst/>
                <a:latin typeface="Times New Roman" panose="02020603050405020304" charset="0"/>
                <a:ea typeface="等线" panose="02010600030101010101" pitchFamily="2" charset="-122"/>
              </a:rPr>
              <a:t>suscal</a:t>
            </a:r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 virus.</a:t>
            </a:r>
            <a:endParaRPr lang="zh-CN" altLang="en-US" sz="1800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148080" y="795020"/>
            <a:ext cx="4340128" cy="2776316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309622" y="795020"/>
            <a:ext cx="6621780" cy="26860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   1     2     3     4     5    6   7     8</a:t>
            </a:r>
            <a:endParaRPr lang="en-US" altLang="zh-CN" dirty="0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34849" y="4035450"/>
            <a:ext cx="7459693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        M:DL2000 DNA Marker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        Lane1: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 Disporopsis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ontrol group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- DCSV-CP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       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Lane2-4: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Disporopsis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experimental groups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-DCSV-CP 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       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Lane5: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 P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 kingianum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ontrol group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- DCSV-CP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         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Lane6-8: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en-US" altLang="zh-CN" i="1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zh-CN" altLang="en-US" i="1" dirty="0">
                <a:latin typeface="Times New Roman" panose="02020603050405020304" charset="0"/>
                <a:cs typeface="Times New Roman" panose="02020603050405020304" charset="0"/>
              </a:rPr>
              <a:t> kingianum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experimental groups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-DCSV-CP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569343" y="1863306"/>
            <a:ext cx="5787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56455" y="1724806"/>
            <a:ext cx="534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1000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7430" y="1249379"/>
            <a:ext cx="534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602268" y="1387878"/>
            <a:ext cx="5787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" name="图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3818" y="795020"/>
            <a:ext cx="1751794" cy="2499751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6855719" y="4035450"/>
            <a:ext cx="3819786" cy="12890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:DL2000 DNA Marker</a:t>
            </a:r>
            <a:endParaRPr lang="en-US" altLang="zh-CN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Lane1-2:</a:t>
            </a:r>
            <a:r>
              <a:rPr lang="zh-CN" altLang="en-US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zh-CN" altLang="zh-CN" sz="1800" i="1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Nicotiana tabacum </a:t>
            </a:r>
            <a:r>
              <a:rPr lang="zh-CN" altLang="zh-CN" sz="1800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var. </a:t>
            </a:r>
            <a:r>
              <a:rPr lang="zh-CN" altLang="zh-CN" sz="1800" i="1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K326</a:t>
            </a:r>
            <a:r>
              <a:rPr lang="en-US" altLang="zh-CN" sz="1800" i="1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zh-CN" sz="1800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experimental groups</a:t>
            </a:r>
            <a:r>
              <a:rPr lang="en-US" altLang="zh-CN" sz="1800" kern="1200" dirty="0">
                <a:solidFill>
                  <a:srgbClr val="000000"/>
                </a:solidFill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-PMNV-CP </a:t>
            </a:r>
            <a:endParaRPr lang="zh-CN" altLang="en-US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330733" y="945450"/>
            <a:ext cx="60973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1      2 </a:t>
            </a:r>
            <a:endParaRPr lang="zh-CN" altLang="en-US" dirty="0"/>
          </a:p>
        </p:txBody>
      </p:sp>
      <p:cxnSp>
        <p:nvCxnSpPr>
          <p:cNvPr id="17" name="直接连接符 16"/>
          <p:cNvCxnSpPr/>
          <p:nvPr/>
        </p:nvCxnSpPr>
        <p:spPr>
          <a:xfrm>
            <a:off x="6309907" y="1863306"/>
            <a:ext cx="5787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5775069" y="1721044"/>
            <a:ext cx="534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1000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775069" y="1327340"/>
            <a:ext cx="534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zh-CN" altLang="en-US" sz="12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6309907" y="1465839"/>
            <a:ext cx="5787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569342" y="5743479"/>
            <a:ext cx="108261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Figure S2: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At 7 day post-inoculation, the control group and the experimental group were detected by RT-PCR with specific primers. A: using specific primer DCSV-cp; B: using specific primer PMNV-CP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654*64"/>
  <p:tag name="TABLE_ENDDRAG_RECT" val="153*118*654*64"/>
</p:tagLst>
</file>

<file path=ppt/tags/tag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commondata" val="eyJoZGlkIjoiOGI4NjI5OTBmMDM1ODFlMDkzNDFlZTFiMWNhZWU5ZTM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2</Words>
  <Application>WPS 演示</Application>
  <PresentationFormat>宽屏</PresentationFormat>
  <Paragraphs>3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倩楠</dc:creator>
  <cp:lastModifiedBy>LQN</cp:lastModifiedBy>
  <cp:revision>2</cp:revision>
  <dcterms:created xsi:type="dcterms:W3CDTF">2024-03-30T12:00:00Z</dcterms:created>
  <dcterms:modified xsi:type="dcterms:W3CDTF">2024-05-18T02:1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7A13C4B44E143659C697C2E5782E240_12</vt:lpwstr>
  </property>
  <property fmtid="{D5CDD505-2E9C-101B-9397-08002B2CF9AE}" pid="3" name="KSOProductBuildVer">
    <vt:lpwstr>2052-12.1.0.16388</vt:lpwstr>
  </property>
</Properties>
</file>